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83" r:id="rId2"/>
    <p:sldId id="284" r:id="rId3"/>
    <p:sldId id="282" r:id="rId4"/>
    <p:sldId id="281" r:id="rId5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524" userDrawn="1">
          <p15:clr>
            <a:srgbClr val="A4A3A4"/>
          </p15:clr>
        </p15:guide>
        <p15:guide id="2" pos="18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6370" autoAdjust="0"/>
  </p:normalViewPr>
  <p:slideViewPr>
    <p:cSldViewPr snapToGrid="0" showGuides="1">
      <p:cViewPr>
        <p:scale>
          <a:sx n="60" d="100"/>
          <a:sy n="60" d="100"/>
        </p:scale>
        <p:origin x="3432" y="534"/>
      </p:cViewPr>
      <p:guideLst>
        <p:guide orient="horz" pos="5524"/>
        <p:guide pos="18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58B885-FEDB-4331-8643-B444CD5E78F8}" type="datetimeFigureOut">
              <a:rPr lang="zh-CN" altLang="en-US" smtClean="0"/>
              <a:t>2018/12/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8B9CEC-2A26-432F-8B7A-68C8D955C6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71495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8B9CEC-2A26-432F-8B7A-68C8D955C600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21854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738612A-E699-4DE0-9E92-65EC8D694C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921A8D2-3295-4D56-A123-A531FCD0792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A98CD51-1A0D-4C74-AEF2-F899EC0D74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6602C-9EB4-4C0E-B06F-4BE2BFCB6B96}" type="datetimeFigureOut">
              <a:rPr lang="zh-CN" altLang="en-US" smtClean="0"/>
              <a:t>2018/12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C9818A-06CD-40D6-96CF-9A48ABCE81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2A6B172-22D6-45FF-A6E4-13152264E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DD0E4-7832-47B4-8EAF-7584B87EED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6398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54FC217-5735-47DD-94C4-E924E829FB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E7A6243-8520-4F24-9E27-7A5E45B24E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B833F9C-D725-4A99-AE08-41F72F3938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6602C-9EB4-4C0E-B06F-4BE2BFCB6B96}" type="datetimeFigureOut">
              <a:rPr lang="zh-CN" altLang="en-US" smtClean="0"/>
              <a:t>2018/12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EC84A18-910F-4ACC-860A-EE2562CCAF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BDF6852-CEA1-4171-BEF1-F035E50149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DD0E4-7832-47B4-8EAF-7584B87EED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2326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A8EA91A-D1EE-43DD-9C88-51061EF80C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1E28C9A-6A48-4366-9E23-B5495E626C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B939CCE-4CBD-47C8-87BD-D5D8CDE8D5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6602C-9EB4-4C0E-B06F-4BE2BFCB6B96}" type="datetimeFigureOut">
              <a:rPr lang="zh-CN" altLang="en-US" smtClean="0"/>
              <a:t>2018/12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E3376B6-0849-4294-9D73-B243A343F2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B2A2F32-0600-4E0A-A125-48A81940D3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DD0E4-7832-47B4-8EAF-7584B87EED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71113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880EDEE-EFC8-4CC0-89D6-B195C066E8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4EA3B23-2EB5-4F86-8BC1-AE86807BF5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558C548-8E08-435C-8D24-79B301FEDD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6602C-9EB4-4C0E-B06F-4BE2BFCB6B96}" type="datetimeFigureOut">
              <a:rPr lang="zh-CN" altLang="en-US" smtClean="0"/>
              <a:t>2018/12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D771B2-E86E-4FE6-9A7D-5EDBAC66C7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E68D10B-5469-4C5A-9F6A-FDF53FB0EF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DD0E4-7832-47B4-8EAF-7584B87EED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5460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559561-66AC-4B11-B060-838156D311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6F26A58-3179-403B-AC49-B70BB2F39F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04E41A8-955F-47A8-9081-648862BF98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6602C-9EB4-4C0E-B06F-4BE2BFCB6B96}" type="datetimeFigureOut">
              <a:rPr lang="zh-CN" altLang="en-US" smtClean="0"/>
              <a:t>2018/12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EB7B5D5-9BCD-4119-A5B3-5280CBCDF2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0146573-49AC-4E29-A322-50E54D6FD1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DD0E4-7832-47B4-8EAF-7584B87EED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4654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064870E-1424-45B6-A17E-34A9D77F32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09EFA93-B772-44D0-9798-7D126E7B3F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09D6F38-5AEF-45E7-8B6E-590E24C651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BE0A417-D75D-4AA5-9BA7-3B200B8768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6602C-9EB4-4C0E-B06F-4BE2BFCB6B96}" type="datetimeFigureOut">
              <a:rPr lang="zh-CN" altLang="en-US" smtClean="0"/>
              <a:t>2018/12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F4181DB-A8A1-485C-8943-437380C29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AA3738E-7803-4001-B29A-1D193F8876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DD0E4-7832-47B4-8EAF-7584B87EED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98899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1921337-C6B0-4972-9C84-D177611071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65B3945-5298-4FC4-8B3B-E083F53D34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FD6B1F7-332E-4E36-92D4-14C83A061B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251A6A2-D029-42D8-9BB7-212B8E2078E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E1D5D84-49CF-4973-BFCC-2B327BAD208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6A44B2C-42F7-4490-A6DB-01748665B8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6602C-9EB4-4C0E-B06F-4BE2BFCB6B96}" type="datetimeFigureOut">
              <a:rPr lang="zh-CN" altLang="en-US" smtClean="0"/>
              <a:t>2018/12/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064370A-3110-4337-9F2C-0FDF146710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B01A728-E73A-4ECC-B38A-C6BB345A41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DD0E4-7832-47B4-8EAF-7584B87EED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47818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35F1D23-34A8-4102-BCEB-B818C466A7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64F48C6-AC4B-4745-9F62-81ED7B9CE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6602C-9EB4-4C0E-B06F-4BE2BFCB6B96}" type="datetimeFigureOut">
              <a:rPr lang="zh-CN" altLang="en-US" smtClean="0"/>
              <a:t>2018/12/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0839FF2-F81E-4693-83ED-0DB5C9F14F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07A20BE-4904-4E8A-81A8-C6E1542BD2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DD0E4-7832-47B4-8EAF-7584B87EED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77556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E6F74DD-D161-4891-8881-4E23637EF2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6602C-9EB4-4C0E-B06F-4BE2BFCB6B96}" type="datetimeFigureOut">
              <a:rPr lang="zh-CN" altLang="en-US" smtClean="0"/>
              <a:t>2018/12/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15A722E-47B8-463B-A13E-45CCADBE92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1C2E9FB-CD9F-4A87-A01C-C0792319B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DD0E4-7832-47B4-8EAF-7584B87EED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06137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9113BE0-6CF4-4C3C-99AD-0F22877E60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A5D6D23-DE17-4EC0-AFAC-905798C5F00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0F752B8-3FD3-4AEF-B216-DA28EE2F62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4BB9378-A413-48D4-95A7-29C14CBC95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6602C-9EB4-4C0E-B06F-4BE2BFCB6B96}" type="datetimeFigureOut">
              <a:rPr lang="zh-CN" altLang="en-US" smtClean="0"/>
              <a:t>2018/12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6413F57-E326-4BD3-B1C8-0BB22F116F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5C95712-A578-4592-8107-1A6F048975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DD0E4-7832-47B4-8EAF-7584B87EED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8110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407671-0CFE-4097-8DAE-CD0C450198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0B099AA-AD7C-4679-9ED1-5576608087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62CDAC3-CDB9-4DEA-A184-B5DB1B52AC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685304C-286F-4F8F-9C99-164FBFA53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6602C-9EB4-4C0E-B06F-4BE2BFCB6B96}" type="datetimeFigureOut">
              <a:rPr lang="zh-CN" altLang="en-US" smtClean="0"/>
              <a:t>2018/12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4642B6B-9932-4D20-A5B3-6D05934379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1EA0B26-AE6B-4DD4-9544-C34194F06C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DD0E4-7832-47B4-8EAF-7584B87EED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48162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9534C00-B668-45A7-A238-5802042247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7078713-A536-4100-B9E0-B712A5C694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99F1387-F8C1-4F9F-9BEE-BED8FBB743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F6602C-9EB4-4C0E-B06F-4BE2BFCB6B96}" type="datetimeFigureOut">
              <a:rPr lang="zh-CN" altLang="en-US" smtClean="0"/>
              <a:t>2018/12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3798F6E-ACD6-4994-AA31-FE3C564273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51D16B4-B961-4536-BC2A-6F0682F418A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BDD0E4-7832-47B4-8EAF-7584B87EED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1686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12.png"/><Relationship Id="rId4" Type="http://schemas.openxmlformats.org/officeDocument/2006/relationships/image" Target="../media/image9.png"/><Relationship Id="rId9" Type="http://schemas.microsoft.com/office/2007/relationships/hdphoto" Target="../media/hdphoto4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7" Type="http://schemas.openxmlformats.org/officeDocument/2006/relationships/image" Target="../media/image17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emf"/><Relationship Id="rId5" Type="http://schemas.openxmlformats.org/officeDocument/2006/relationships/image" Target="../media/image15.emf"/><Relationship Id="rId4" Type="http://schemas.openxmlformats.org/officeDocument/2006/relationships/image" Target="../media/image1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21">
            <a:extLst>
              <a:ext uri="{FF2B5EF4-FFF2-40B4-BE49-F238E27FC236}">
                <a16:creationId xmlns:a16="http://schemas.microsoft.com/office/drawing/2014/main" id="{18B02335-FD19-4A2E-AFCA-F302A69DBBDB}"/>
              </a:ext>
            </a:extLst>
          </p:cNvPr>
          <p:cNvSpPr txBox="1"/>
          <p:nvPr/>
        </p:nvSpPr>
        <p:spPr>
          <a:xfrm>
            <a:off x="5539740" y="0"/>
            <a:ext cx="13182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NZ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S1</a:t>
            </a:r>
          </a:p>
        </p:txBody>
      </p:sp>
      <p:pic>
        <p:nvPicPr>
          <p:cNvPr id="4" name="Picture 10">
            <a:extLst>
              <a:ext uri="{FF2B5EF4-FFF2-40B4-BE49-F238E27FC236}">
                <a16:creationId xmlns:a16="http://schemas.microsoft.com/office/drawing/2014/main" id="{6BB0456A-E5CF-4E2D-B86B-7678FE642D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8772" y="603431"/>
            <a:ext cx="2757451" cy="2113440"/>
          </a:xfrm>
          <a:prstGeom prst="rect">
            <a:avLst/>
          </a:prstGeom>
        </p:spPr>
      </p:pic>
      <p:pic>
        <p:nvPicPr>
          <p:cNvPr id="5" name="Picture 11">
            <a:extLst>
              <a:ext uri="{FF2B5EF4-FFF2-40B4-BE49-F238E27FC236}">
                <a16:creationId xmlns:a16="http://schemas.microsoft.com/office/drawing/2014/main" id="{2419438A-4E42-41EA-B0A8-430F3377D5B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59595" y="603431"/>
            <a:ext cx="2757451" cy="2113440"/>
          </a:xfrm>
          <a:prstGeom prst="rect">
            <a:avLst/>
          </a:prstGeom>
        </p:spPr>
      </p:pic>
      <p:pic>
        <p:nvPicPr>
          <p:cNvPr id="6" name="Picture 16">
            <a:extLst>
              <a:ext uri="{FF2B5EF4-FFF2-40B4-BE49-F238E27FC236}">
                <a16:creationId xmlns:a16="http://schemas.microsoft.com/office/drawing/2014/main" id="{F4B2F240-1C6B-47A3-B400-44C3379DD18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8771" y="2788080"/>
            <a:ext cx="2757451" cy="2113440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40591045-8154-40D4-AD8E-78A547898EF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59595" y="2901537"/>
            <a:ext cx="2653842" cy="2066997"/>
          </a:xfrm>
          <a:prstGeom prst="rect">
            <a:avLst/>
          </a:prstGeom>
        </p:spPr>
      </p:pic>
      <p:sp>
        <p:nvSpPr>
          <p:cNvPr id="23" name="TextBox 3">
            <a:extLst>
              <a:ext uri="{FF2B5EF4-FFF2-40B4-BE49-F238E27FC236}">
                <a16:creationId xmlns:a16="http://schemas.microsoft.com/office/drawing/2014/main" id="{24660012-09F2-4389-997E-D0A83AF6C882}"/>
              </a:ext>
            </a:extLst>
          </p:cNvPr>
          <p:cNvSpPr txBox="1"/>
          <p:nvPr/>
        </p:nvSpPr>
        <p:spPr>
          <a:xfrm>
            <a:off x="308771" y="347556"/>
            <a:ext cx="466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4" name="TextBox 22">
            <a:extLst>
              <a:ext uri="{FF2B5EF4-FFF2-40B4-BE49-F238E27FC236}">
                <a16:creationId xmlns:a16="http://schemas.microsoft.com/office/drawing/2014/main" id="{8EFACF30-0FE4-4A7D-932A-154D60F57611}"/>
              </a:ext>
            </a:extLst>
          </p:cNvPr>
          <p:cNvSpPr txBox="1"/>
          <p:nvPr/>
        </p:nvSpPr>
        <p:spPr>
          <a:xfrm>
            <a:off x="3452362" y="347556"/>
            <a:ext cx="653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NZ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0" lang="en-NZ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5" name="TextBox 22">
            <a:extLst>
              <a:ext uri="{FF2B5EF4-FFF2-40B4-BE49-F238E27FC236}">
                <a16:creationId xmlns:a16="http://schemas.microsoft.com/office/drawing/2014/main" id="{246953B8-6541-4A5B-96CF-BB8E407BDC48}"/>
              </a:ext>
            </a:extLst>
          </p:cNvPr>
          <p:cNvSpPr txBox="1"/>
          <p:nvPr/>
        </p:nvSpPr>
        <p:spPr>
          <a:xfrm>
            <a:off x="308771" y="2611980"/>
            <a:ext cx="653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NZ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C</a:t>
            </a:r>
          </a:p>
        </p:txBody>
      </p:sp>
      <p:sp>
        <p:nvSpPr>
          <p:cNvPr id="26" name="TextBox 22">
            <a:extLst>
              <a:ext uri="{FF2B5EF4-FFF2-40B4-BE49-F238E27FC236}">
                <a16:creationId xmlns:a16="http://schemas.microsoft.com/office/drawing/2014/main" id="{61372906-57A3-4663-85A5-3B8AE1F01CA1}"/>
              </a:ext>
            </a:extLst>
          </p:cNvPr>
          <p:cNvSpPr txBox="1"/>
          <p:nvPr/>
        </p:nvSpPr>
        <p:spPr>
          <a:xfrm>
            <a:off x="3452362" y="2611980"/>
            <a:ext cx="653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NZ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1291586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21">
            <a:extLst>
              <a:ext uri="{FF2B5EF4-FFF2-40B4-BE49-F238E27FC236}">
                <a16:creationId xmlns:a16="http://schemas.microsoft.com/office/drawing/2014/main" id="{18B02335-FD19-4A2E-AFCA-F302A69DBBDB}"/>
              </a:ext>
            </a:extLst>
          </p:cNvPr>
          <p:cNvSpPr txBox="1"/>
          <p:nvPr/>
        </p:nvSpPr>
        <p:spPr>
          <a:xfrm>
            <a:off x="5539740" y="0"/>
            <a:ext cx="13182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NZ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13" name="TextBox 3">
            <a:extLst>
              <a:ext uri="{FF2B5EF4-FFF2-40B4-BE49-F238E27FC236}">
                <a16:creationId xmlns:a16="http://schemas.microsoft.com/office/drawing/2014/main" id="{B2D64CA8-D350-4CA9-B74D-41A333C3065E}"/>
              </a:ext>
            </a:extLst>
          </p:cNvPr>
          <p:cNvSpPr txBox="1"/>
          <p:nvPr/>
        </p:nvSpPr>
        <p:spPr>
          <a:xfrm>
            <a:off x="1577036" y="472945"/>
            <a:ext cx="466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4" name="TextBox 3">
            <a:extLst>
              <a:ext uri="{FF2B5EF4-FFF2-40B4-BE49-F238E27FC236}">
                <a16:creationId xmlns:a16="http://schemas.microsoft.com/office/drawing/2014/main" id="{A7ACFC61-BD21-4A86-A529-643D618D4EFE}"/>
              </a:ext>
            </a:extLst>
          </p:cNvPr>
          <p:cNvSpPr txBox="1"/>
          <p:nvPr/>
        </p:nvSpPr>
        <p:spPr>
          <a:xfrm>
            <a:off x="1577036" y="3409624"/>
            <a:ext cx="466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5" name="TextBox 3">
            <a:extLst>
              <a:ext uri="{FF2B5EF4-FFF2-40B4-BE49-F238E27FC236}">
                <a16:creationId xmlns:a16="http://schemas.microsoft.com/office/drawing/2014/main" id="{DF257DDC-272E-4A97-883A-4ED288CC360B}"/>
              </a:ext>
            </a:extLst>
          </p:cNvPr>
          <p:cNvSpPr txBox="1"/>
          <p:nvPr/>
        </p:nvSpPr>
        <p:spPr>
          <a:xfrm>
            <a:off x="1577036" y="6337479"/>
            <a:ext cx="5784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</a:t>
            </a: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B9510214-9E99-40ED-86F1-D327B6D850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40549" y="560582"/>
            <a:ext cx="3803020" cy="291600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894ED42C-6D4B-4B6B-8076-3DA47DD291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53618" y="3475911"/>
            <a:ext cx="3803015" cy="291600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EADC1618-15D8-4C53-A53A-1B1C4BA2DFA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53612" y="6391239"/>
            <a:ext cx="3803016" cy="291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33644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21">
            <a:extLst>
              <a:ext uri="{FF2B5EF4-FFF2-40B4-BE49-F238E27FC236}">
                <a16:creationId xmlns:a16="http://schemas.microsoft.com/office/drawing/2014/main" id="{2A350A27-3974-416F-9C08-A47B46380A55}"/>
              </a:ext>
            </a:extLst>
          </p:cNvPr>
          <p:cNvSpPr txBox="1"/>
          <p:nvPr/>
        </p:nvSpPr>
        <p:spPr>
          <a:xfrm>
            <a:off x="5539740" y="0"/>
            <a:ext cx="13182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NZ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S3</a:t>
            </a: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A5E1DA63-0D2F-4A4D-8EAB-B13CD0938E46}"/>
              </a:ext>
            </a:extLst>
          </p:cNvPr>
          <p:cNvGrpSpPr/>
          <p:nvPr/>
        </p:nvGrpSpPr>
        <p:grpSpPr>
          <a:xfrm>
            <a:off x="1505354" y="697355"/>
            <a:ext cx="3847291" cy="5823300"/>
            <a:chOff x="1532104" y="268095"/>
            <a:chExt cx="3847291" cy="5823300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EC17C8A7-900E-4010-A867-5E1B2CE6EF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screen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"/>
                      </a14:imgEffect>
                      <a14:imgEffect>
                        <a14:brightnessContrast bright="12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32107" y="2279745"/>
              <a:ext cx="1800000" cy="1800000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B85A60D0-1FAE-4E77-83B6-AFBD318EC7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screen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15000" contrast="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579395" y="4291395"/>
              <a:ext cx="1800000" cy="1800000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25F3DCAD-1752-4261-B11D-F94ACDBC78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screen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7000"/>
                      </a14:imgEffect>
                      <a14:imgEffect>
                        <a14:brightnessContrast bright="23000" contrast="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555750" y="268095"/>
              <a:ext cx="1800000" cy="1800000"/>
            </a:xfrm>
            <a:prstGeom prst="rect">
              <a:avLst/>
            </a:prstGeom>
          </p:spPr>
        </p:pic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1D7576D6-203A-448E-948E-D965C96FB409}"/>
                </a:ext>
              </a:extLst>
            </p:cNvPr>
            <p:cNvSpPr txBox="1"/>
            <p:nvPr/>
          </p:nvSpPr>
          <p:spPr>
            <a:xfrm>
              <a:off x="1532104" y="2279745"/>
              <a:ext cx="124197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r>
                <a:rPr lang="en-US" altLang="zh-CN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L-arginine</a:t>
              </a:r>
              <a:endParaRPr lang="zh-CN" altLang="en-US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03D2D188-FD5F-4538-81EE-7F62550634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screen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32104" y="4291395"/>
              <a:ext cx="1800000" cy="1800000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61950E25-7995-4DF4-AF2B-B75153CA697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screen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harpenSoften amount="5000"/>
                      </a14:imgEffect>
                      <a14:imgEffect>
                        <a14:brightnessContrast bright="12000" contrast="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579395" y="2279745"/>
              <a:ext cx="1800000" cy="1800000"/>
            </a:xfrm>
            <a:prstGeom prst="rect">
              <a:avLst/>
            </a:prstGeom>
          </p:spPr>
        </p:pic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C46069D8-2CDF-42D3-9792-DD117E6584CB}"/>
                </a:ext>
              </a:extLst>
            </p:cNvPr>
            <p:cNvSpPr txBox="1"/>
            <p:nvPr/>
          </p:nvSpPr>
          <p:spPr>
            <a:xfrm>
              <a:off x="3579395" y="2279745"/>
              <a:ext cx="136225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pif</a:t>
              </a:r>
              <a:r>
                <a:rPr lang="en-US" altLang="zh-CN" sz="1100" b="1" baseline="30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en-US" altLang="zh-CN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L-arginine</a:t>
              </a:r>
              <a:endParaRPr lang="zh-CN" altLang="en-US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" name="TextBox 17">
            <a:extLst>
              <a:ext uri="{FF2B5EF4-FFF2-40B4-BE49-F238E27FC236}">
                <a16:creationId xmlns:a16="http://schemas.microsoft.com/office/drawing/2014/main" id="{12910B0C-9218-46BB-B206-738356716A0A}"/>
              </a:ext>
            </a:extLst>
          </p:cNvPr>
          <p:cNvSpPr txBox="1"/>
          <p:nvPr/>
        </p:nvSpPr>
        <p:spPr>
          <a:xfrm>
            <a:off x="2529000" y="697355"/>
            <a:ext cx="14156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Saline    </a:t>
            </a: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3B6C8EF1-B6DF-4045-A7DA-E439DB32A456}"/>
              </a:ext>
            </a:extLst>
          </p:cNvPr>
          <p:cNvSpPr txBox="1"/>
          <p:nvPr/>
        </p:nvSpPr>
        <p:spPr>
          <a:xfrm>
            <a:off x="1505353" y="4720655"/>
            <a:ext cx="12419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zh-CN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L-histidine</a:t>
            </a:r>
            <a:endParaRPr lang="zh-CN" altLang="en-US" sz="11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8312D6C0-B58E-4294-83D7-968F49E7C27A}"/>
              </a:ext>
            </a:extLst>
          </p:cNvPr>
          <p:cNvSpPr txBox="1"/>
          <p:nvPr/>
        </p:nvSpPr>
        <p:spPr>
          <a:xfrm>
            <a:off x="3552645" y="4720655"/>
            <a:ext cx="13622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pif</a:t>
            </a:r>
            <a:r>
              <a:rPr lang="en-US" altLang="zh-CN" sz="1100" b="1" baseline="30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/- </a:t>
            </a:r>
            <a:r>
              <a:rPr lang="en-US" altLang="zh-CN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-histidine</a:t>
            </a:r>
            <a:endParaRPr lang="zh-CN" altLang="en-US" sz="11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" name="组合 27">
            <a:extLst>
              <a:ext uri="{FF2B5EF4-FFF2-40B4-BE49-F238E27FC236}">
                <a16:creationId xmlns:a16="http://schemas.microsoft.com/office/drawing/2014/main" id="{48E53247-DEF3-45B5-9108-7EDE973B3916}"/>
              </a:ext>
            </a:extLst>
          </p:cNvPr>
          <p:cNvGrpSpPr/>
          <p:nvPr/>
        </p:nvGrpSpPr>
        <p:grpSpPr>
          <a:xfrm>
            <a:off x="4788402" y="6244028"/>
            <a:ext cx="653143" cy="238527"/>
            <a:chOff x="6349469" y="2474845"/>
            <a:chExt cx="653143" cy="238527"/>
          </a:xfrm>
        </p:grpSpPr>
        <p:cxnSp>
          <p:nvCxnSpPr>
            <p:cNvPr id="29" name="直接连接符 28">
              <a:extLst>
                <a:ext uri="{FF2B5EF4-FFF2-40B4-BE49-F238E27FC236}">
                  <a16:creationId xmlns:a16="http://schemas.microsoft.com/office/drawing/2014/main" id="{5B008821-64E7-4524-9D45-07237A5789C8}"/>
                </a:ext>
              </a:extLst>
            </p:cNvPr>
            <p:cNvCxnSpPr/>
            <p:nvPr/>
          </p:nvCxnSpPr>
          <p:spPr>
            <a:xfrm>
              <a:off x="6466726" y="2686595"/>
              <a:ext cx="288000" cy="0"/>
            </a:xfrm>
            <a:prstGeom prst="line">
              <a:avLst/>
            </a:prstGeom>
            <a:ln w="254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EC5F1161-4D52-4F5E-9E51-A0A63E77668C}"/>
                </a:ext>
              </a:extLst>
            </p:cNvPr>
            <p:cNvSpPr txBox="1"/>
            <p:nvPr/>
          </p:nvSpPr>
          <p:spPr>
            <a:xfrm>
              <a:off x="6349469" y="2474845"/>
              <a:ext cx="653143" cy="2385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altLang="zh-CN" sz="95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l-GR" altLang="zh-CN" sz="95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GB" altLang="zh-CN" sz="95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GB" altLang="zh-CN" sz="950" dirty="0"/>
                <a:t> </a:t>
              </a:r>
              <a:endParaRPr lang="zh-CN" altLang="en-US" sz="950" dirty="0"/>
            </a:p>
          </p:txBody>
        </p:sp>
      </p:grpSp>
    </p:spTree>
    <p:extLst>
      <p:ext uri="{BB962C8B-B14F-4D97-AF65-F5344CB8AC3E}">
        <p14:creationId xmlns:p14="http://schemas.microsoft.com/office/powerpoint/2010/main" val="37125581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BA3FB700-CE07-44AD-A0F8-9266A917EA6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87848" y="2926227"/>
            <a:ext cx="3205199" cy="2242759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4FCF9889-A607-40FD-86B4-E678659A26B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86908" y="682782"/>
            <a:ext cx="3196885" cy="2236941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5B630075-664B-4968-93D8-55CD6E512BF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4022" y="5190270"/>
            <a:ext cx="3196884" cy="2236940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9159496C-EAF7-4A81-8655-D2A46DA4A93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1042" y="2932045"/>
            <a:ext cx="3196885" cy="2236941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F9D4CAA7-6C78-4020-A008-1A126CCE21F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2542" y="682783"/>
            <a:ext cx="3196884" cy="2236940"/>
          </a:xfrm>
          <a:prstGeom prst="rect">
            <a:avLst/>
          </a:prstGeom>
        </p:spPr>
      </p:pic>
      <p:sp>
        <p:nvSpPr>
          <p:cNvPr id="16" name="TextBox 16">
            <a:extLst>
              <a:ext uri="{FF2B5EF4-FFF2-40B4-BE49-F238E27FC236}">
                <a16:creationId xmlns:a16="http://schemas.microsoft.com/office/drawing/2014/main" id="{F03C4C06-759C-48A1-9897-202CC7861FD7}"/>
              </a:ext>
            </a:extLst>
          </p:cNvPr>
          <p:cNvSpPr txBox="1"/>
          <p:nvPr/>
        </p:nvSpPr>
        <p:spPr>
          <a:xfrm>
            <a:off x="280816" y="5934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R="0" lvl="0" indent="0" fontAlgn="auto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kumimoji="0" b="1" i="0" u="none" strike="noStrike" cap="none" spc="0" normalizeH="0" baseline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GB" dirty="0"/>
              <a:t>A</a:t>
            </a:r>
          </a:p>
        </p:txBody>
      </p:sp>
      <p:sp>
        <p:nvSpPr>
          <p:cNvPr id="17" name="TextBox 17">
            <a:extLst>
              <a:ext uri="{FF2B5EF4-FFF2-40B4-BE49-F238E27FC236}">
                <a16:creationId xmlns:a16="http://schemas.microsoft.com/office/drawing/2014/main" id="{71542944-4A2D-425F-B6E0-250350682971}"/>
              </a:ext>
            </a:extLst>
          </p:cNvPr>
          <p:cNvSpPr txBox="1"/>
          <p:nvPr/>
        </p:nvSpPr>
        <p:spPr>
          <a:xfrm>
            <a:off x="3530381" y="5934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" name="TextBox 18">
            <a:extLst>
              <a:ext uri="{FF2B5EF4-FFF2-40B4-BE49-F238E27FC236}">
                <a16:creationId xmlns:a16="http://schemas.microsoft.com/office/drawing/2014/main" id="{87C87F21-3521-441B-8E46-21707DE9E315}"/>
              </a:ext>
            </a:extLst>
          </p:cNvPr>
          <p:cNvSpPr txBox="1"/>
          <p:nvPr/>
        </p:nvSpPr>
        <p:spPr>
          <a:xfrm>
            <a:off x="280816" y="284352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9" name="TextBox 19">
            <a:extLst>
              <a:ext uri="{FF2B5EF4-FFF2-40B4-BE49-F238E27FC236}">
                <a16:creationId xmlns:a16="http://schemas.microsoft.com/office/drawing/2014/main" id="{4646066A-7570-46B2-BBAD-DD7529028E86}"/>
              </a:ext>
            </a:extLst>
          </p:cNvPr>
          <p:cNvSpPr txBox="1"/>
          <p:nvPr/>
        </p:nvSpPr>
        <p:spPr>
          <a:xfrm>
            <a:off x="3530381" y="2843523"/>
            <a:ext cx="3497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0" name="TextBox 18">
            <a:extLst>
              <a:ext uri="{FF2B5EF4-FFF2-40B4-BE49-F238E27FC236}">
                <a16:creationId xmlns:a16="http://schemas.microsoft.com/office/drawing/2014/main" id="{87C87F21-3521-441B-8E46-21707DE9E315}"/>
              </a:ext>
            </a:extLst>
          </p:cNvPr>
          <p:cNvSpPr txBox="1"/>
          <p:nvPr/>
        </p:nvSpPr>
        <p:spPr>
          <a:xfrm>
            <a:off x="280816" y="509320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3" name="TextBox 21">
            <a:extLst>
              <a:ext uri="{FF2B5EF4-FFF2-40B4-BE49-F238E27FC236}">
                <a16:creationId xmlns:a16="http://schemas.microsoft.com/office/drawing/2014/main" id="{9F0600E7-8A4D-426A-874B-7DD74B5243AC}"/>
              </a:ext>
            </a:extLst>
          </p:cNvPr>
          <p:cNvSpPr txBox="1"/>
          <p:nvPr/>
        </p:nvSpPr>
        <p:spPr>
          <a:xfrm>
            <a:off x="5539740" y="0"/>
            <a:ext cx="13182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NZ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1079129546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6</TotalTime>
  <Words>37</Words>
  <Application>Microsoft Office PowerPoint</Application>
  <PresentationFormat>A4 纸张(210x297 毫米)</PresentationFormat>
  <Paragraphs>23</Paragraphs>
  <Slides>4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1_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o linbo</dc:creator>
  <cp:lastModifiedBy>Huang</cp:lastModifiedBy>
  <cp:revision>95</cp:revision>
  <dcterms:created xsi:type="dcterms:W3CDTF">2018-08-14T02:34:24Z</dcterms:created>
  <dcterms:modified xsi:type="dcterms:W3CDTF">2018-12-05T03:14:01Z</dcterms:modified>
</cp:coreProperties>
</file>